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8887B9-0FFA-42DF-A641-8051600B4EC6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98D336-AD76-4F2C-A190-C3BBE14AA78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75861A-AAD6-4CDD-ADAC-B74E11FC6C3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2A0483-ED7C-40A6-A000-E42BA472DBE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1"/>
          <p:cNvSpPr>
            <a:spLocks noGrp="1"/>
          </p:cNvSpPr>
          <p:nvPr>
            <p:ph type="sldImg"/>
          </p:nvPr>
        </p:nvSpPr>
        <p:spPr>
          <a:xfrm>
            <a:off x="11462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665E4-15F0-444F-9064-99DE47C480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D278F-D0E8-43AB-8AFF-30C0E5A41D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E9AF4-2A0C-45B9-B4EB-F96781D1AB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A208E-3320-4503-9C08-705C22AB35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D5604-409C-4582-8FA0-3F8FF38207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88488-67F7-4E0C-A8F8-9DE62E98A8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F0152-5905-4690-A30E-7997C5E919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B9639-C16A-4E7E-A8C9-CBCC71EB19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F2FFA-F048-40DA-9417-1C08450773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23EA7-2352-4B11-8443-2E8B6F939B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14760-C0D2-4DD1-8E39-A3784103E5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C04F8-E98D-49EF-9B6F-9A04F9F5B1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87CCF1-8FC7-4F9F-A963-601D43679FC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4"/>
          <p:cNvGraphicFramePr/>
          <p:nvPr/>
        </p:nvGraphicFramePr>
        <p:xfrm>
          <a:off x="4795920" y="961920"/>
          <a:ext cx="3633840" cy="29196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9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795920" y="961920"/>
                    <a:ext cx="3633840" cy="291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7"/>
          <p:cNvSpPr/>
          <p:nvPr/>
        </p:nvSpPr>
        <p:spPr>
          <a:xfrm>
            <a:off x="6521760" y="134604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8"/>
          <p:cNvSpPr/>
          <p:nvPr/>
        </p:nvSpPr>
        <p:spPr>
          <a:xfrm>
            <a:off x="6890040" y="151776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Object 3"/>
          <p:cNvGraphicFramePr/>
          <p:nvPr/>
        </p:nvGraphicFramePr>
        <p:xfrm>
          <a:off x="968400" y="890640"/>
          <a:ext cx="3429000" cy="30654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3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68400" y="890640"/>
                    <a:ext cx="3429000" cy="306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 Box 18"/>
          <p:cNvSpPr/>
          <p:nvPr/>
        </p:nvSpPr>
        <p:spPr>
          <a:xfrm>
            <a:off x="2829240" y="132228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3197520" y="149400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0"/>
          <p:cNvSpPr/>
          <p:nvPr/>
        </p:nvSpPr>
        <p:spPr>
          <a:xfrm>
            <a:off x="2568600" y="1525680"/>
            <a:ext cx="12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1"/>
          <p:cNvSpPr/>
          <p:nvPr/>
        </p:nvSpPr>
        <p:spPr>
          <a:xfrm>
            <a:off x="3216240" y="168912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2"/>
          <p:cNvSpPr/>
          <p:nvPr/>
        </p:nvSpPr>
        <p:spPr>
          <a:xfrm rot="16200000">
            <a:off x="181440" y="2134440"/>
            <a:ext cx="1395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Irs1 mRNA leve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(Arbitrary unit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2"/>
          <p:cNvSpPr/>
          <p:nvPr/>
        </p:nvSpPr>
        <p:spPr>
          <a:xfrm rot="16200000">
            <a:off x="4028040" y="2134440"/>
            <a:ext cx="1395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Irs1 mRNA leve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(Arbitrary unit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1351800" y="1353960"/>
            <a:ext cx="44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5334120" y="1325520"/>
            <a:ext cx="70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6"/>
          <p:cNvSpPr/>
          <p:nvPr/>
        </p:nvSpPr>
        <p:spPr>
          <a:xfrm>
            <a:off x="903240" y="744480"/>
            <a:ext cx="33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4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7"/>
          <p:cNvSpPr/>
          <p:nvPr/>
        </p:nvSpPr>
        <p:spPr>
          <a:xfrm>
            <a:off x="4483800" y="744480"/>
            <a:ext cx="32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4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4"/>
          <p:cNvSpPr/>
          <p:nvPr/>
        </p:nvSpPr>
        <p:spPr>
          <a:xfrm>
            <a:off x="1472040" y="3483000"/>
            <a:ext cx="589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liv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5"/>
          <p:cNvSpPr/>
          <p:nvPr/>
        </p:nvSpPr>
        <p:spPr>
          <a:xfrm>
            <a:off x="2064240" y="34830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6"/>
          <p:cNvSpPr/>
          <p:nvPr/>
        </p:nvSpPr>
        <p:spPr>
          <a:xfrm>
            <a:off x="2832480" y="34830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 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+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7"/>
          <p:cNvSpPr/>
          <p:nvPr/>
        </p:nvSpPr>
        <p:spPr>
          <a:xfrm>
            <a:off x="3553200" y="34830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5"/>
          <p:cNvSpPr/>
          <p:nvPr/>
        </p:nvSpPr>
        <p:spPr>
          <a:xfrm>
            <a:off x="5569200" y="34686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+/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6"/>
          <p:cNvSpPr/>
          <p:nvPr/>
        </p:nvSpPr>
        <p:spPr>
          <a:xfrm>
            <a:off x="6504480" y="34686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 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+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7"/>
          <p:cNvSpPr/>
          <p:nvPr/>
        </p:nvSpPr>
        <p:spPr>
          <a:xfrm>
            <a:off x="7453800" y="3468600"/>
            <a:ext cx="657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i="1" lang="en-US" sz="1400" spc="-1" strike="noStrike" baseline="30000">
                <a:solidFill>
                  <a:srgbClr val="000000"/>
                </a:solidFill>
                <a:latin typeface="Calibri"/>
              </a:rPr>
              <a:t>-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idne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5"/>
          <p:cNvSpPr/>
          <p:nvPr/>
        </p:nvSpPr>
        <p:spPr>
          <a:xfrm>
            <a:off x="5837400" y="1538280"/>
            <a:ext cx="18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8"/>
          <p:cNvSpPr/>
          <p:nvPr/>
        </p:nvSpPr>
        <p:spPr>
          <a:xfrm>
            <a:off x="6773760" y="1754280"/>
            <a:ext cx="93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"/>
          <p:cNvSpPr/>
          <p:nvPr/>
        </p:nvSpPr>
        <p:spPr>
          <a:xfrm>
            <a:off x="830160" y="4563000"/>
            <a:ext cx="76392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Additional File 1 Figure S1. Elevated IRS1 gene expression in the kidneys of male 13-14 wk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Irs2</a:t>
            </a:r>
            <a:r>
              <a:rPr b="1" lang="en-GB" sz="12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-/-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diabetic mi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Quantitative TaqMan PCR was performed using IRS1 specific oligonucleotides as described in Material and Method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ΔΔCt values were calculated by dividing the Ct values for IRS1 by those for the 18S control performed simultaneously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and fold change was then calculated by setting the wild-type liver (A) or the wild-type kidney (B) group value to 1. Dat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are expressed as mean +/- SEM, n=5 for each group. Statistical significance was determined using one way ANOVA with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바탕"/>
              </a:rPr>
              <a:t>post hoc Tukey Kramer multiple comparisons test, *** p&lt; 0.00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9T11:40:55Z</dcterms:created>
  <dc:creator>QUB</dc:creator>
  <dc:description/>
  <dc:language>en-US</dc:language>
  <cp:lastModifiedBy>QUB</cp:lastModifiedBy>
  <dcterms:modified xsi:type="dcterms:W3CDTF">2010-06-27T11:30:02Z</dcterms:modified>
  <cp:revision>4</cp:revision>
  <dc:subject/>
  <dc:title>Slide 1</dc:title>
</cp:coreProperties>
</file>